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543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161782-89C5-33B6-E471-046D1997D4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13A281A-6117-5359-A511-12EF982CDA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69272D-B657-A314-03AF-91BADA45A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C83444-4FA4-A6D3-E037-2C86A74E8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AABFE6-EC3F-9349-9E5A-E909407AC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039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4E3A4C-FC72-38FA-FFE2-1D6FD98881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C830BB2-D54F-ECD9-E130-BDAEA25A8A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C554C1-115B-ABB7-1B65-C4A2E481B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191524-C3BA-68F4-FA9C-2CADFDC37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3752D2-52FF-B80A-C348-0C00A54EB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3696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ECA5984-3EDF-7703-EBD7-67214CBEDE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8ADC53D-8F3A-2B1E-DAC5-AD835DE46E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12FBB2-50D2-52ED-1F27-DE9072AC4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9D426A-1B5F-0187-7520-3486485CF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F611D3-8B0F-0C09-D140-33E6D7E64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7540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08F750-B590-3DEC-47FF-F16C0C0B3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B52794-07B8-09F6-0D3B-DB586F95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2CBD7B-94B9-34DC-5DCB-AABF2003D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0F4EB3-E0F8-6E48-E08A-883D5AC70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44D26F-9ACE-DCF5-E111-364C85267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854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29143C-6B71-6BE2-A761-7CA1A039B5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F69476-F53A-70F9-1BCA-96276947E3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EE69C8-3000-846F-CE0A-F5C213144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92B501-1112-E211-1153-240C8DC54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E0CA2F-95C8-29BB-3A1F-B92888FDA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4715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6757EB-FCC4-B363-2D17-7240AA0D49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EA30A9B-6892-A87A-10B6-3A6CFAF8DF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4D1B6E-B832-6D99-CF42-C76C8E199C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5691C8-F6E9-4818-4E24-05687EEB4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25C7CB-BE10-6204-4AA5-CB6CA64CF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02E1CB-07A5-9C04-07A1-D6590F3B3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8260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6454FC-56CB-1AF3-502C-7942F75F2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B974780-803E-FE9F-F69C-60ADD8B4B5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2A4910-E302-0446-CAE0-E038B8DD8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24A0512-3F1B-5DFD-549F-DAD84388A5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5207973-8DF0-ED90-BCEC-88196923CB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6B5546D-DEC0-12B3-0FB2-EBEEE8EBB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ED23D99-B45C-A019-3FB3-F22CBF988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14FFD66-95A0-FBB7-9E10-9DAA482D4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844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9A9750-A272-1AB3-6D58-F19C483C5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C6D0FAB-3E05-6F45-9D25-28237929B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645BC22-17BC-98A2-C28F-41B19A061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4802412-B762-064D-B08D-EC98DA4C4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974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E5511AC-8E8B-7A81-3683-370A97DF2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85BA46D-DCB5-1296-5161-3EA0FAA2E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A351C27-8497-51F8-E894-FCFC10072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694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EEDEC6-A1DE-DD73-1037-6AA68FC88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127D79-07ED-06C9-4113-BE7B6204F0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14EC88-05AE-C22E-386F-89458036DA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2E222C-3B3C-9125-A969-AB855E8A6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16264D-EFB4-1827-AE9A-1C117DB9B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C60862-03DE-2FC6-F57D-FD6D3ED38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182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518E5E-FED7-E507-1A3C-8C03795FE1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0FDC0F9-7A79-5806-9DA5-19D4F55F88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569A418-E5D5-E40D-A9A4-204851D541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9D0DE3D-32FD-A278-B1AD-635EEF433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C9F6AD-FFD4-BE3C-DC52-20AEE482C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E77555-F93F-9402-7BD7-E0BD08A98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62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5881CC7-2565-E91D-72DD-9739747D8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748D68F-460E-D810-9100-F97B7375D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8FB038-01E4-3828-3E63-7705E22A39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97F99-D0F9-403E-B90A-F66547882963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4B0D6C-63D4-1F93-FD51-659A3DFA62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00E781-03C1-6D4D-67EE-012A2FC50B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B6E88-120D-48BF-ABDD-CC2111D72F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6912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2534E5-BCDE-6F2F-FEFF-CD6CD759F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z="18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2.</a:t>
            </a:r>
            <a:r>
              <a:rPr lang="en-US" altLang="zh-CN" sz="1800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unnel plots for TEAEs, TESAEs, hyperkalemia, and the discontinuation of treatment due to the adverse events.</a:t>
            </a:r>
            <a:br>
              <a:rPr lang="zh-CN" altLang="zh-CN" sz="1800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lang="zh-CN" altLang="en-US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FCE990B9-FF5A-5E50-3968-785A330AAB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r="627"/>
          <a:stretch/>
        </p:blipFill>
        <p:spPr bwMode="auto">
          <a:xfrm>
            <a:off x="838200" y="2543493"/>
            <a:ext cx="10515600" cy="291560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435826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Supplementary figure S2. Funnel plots for TEAEs, TESAEs, hyperkalemia, and the discontinuation of treatment due to the adverse event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万乾 余</dc:creator>
  <cp:lastModifiedBy>万乾 余</cp:lastModifiedBy>
  <cp:revision>1</cp:revision>
  <dcterms:created xsi:type="dcterms:W3CDTF">2025-01-03T17:42:41Z</dcterms:created>
  <dcterms:modified xsi:type="dcterms:W3CDTF">2025-01-03T17:43:07Z</dcterms:modified>
</cp:coreProperties>
</file>